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79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–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–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12" autoAdjust="0"/>
    <p:restoredTop sz="82862" autoAdjust="0"/>
  </p:normalViewPr>
  <p:slideViewPr>
    <p:cSldViewPr snapToGrid="0" snapToObjects="1">
      <p:cViewPr>
        <p:scale>
          <a:sx n="125" d="100"/>
          <a:sy n="125" d="100"/>
        </p:scale>
        <p:origin x="-4860" y="-822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ter Alexander" userId="6766396f-6837-4e3e-aa63-6649ea648b73" providerId="ADAL" clId="{B23E332B-9C9D-4BDB-AA2B-DEC72DABD394}"/>
    <pc:docChg chg="custSel modSld">
      <pc:chgData name="Peter Alexander" userId="6766396f-6837-4e3e-aa63-6649ea648b73" providerId="ADAL" clId="{B23E332B-9C9D-4BDB-AA2B-DEC72DABD394}" dt="2022-08-29T00:13:05.496" v="255"/>
      <pc:docMkLst>
        <pc:docMk/>
      </pc:docMkLst>
      <pc:sldChg chg="delSp modSp mod">
        <pc:chgData name="Peter Alexander" userId="6766396f-6837-4e3e-aa63-6649ea648b73" providerId="ADAL" clId="{B23E332B-9C9D-4BDB-AA2B-DEC72DABD394}" dt="2022-08-29T00:13:05.496" v="255"/>
        <pc:sldMkLst>
          <pc:docMk/>
          <pc:sldMk cId="10483774" sldId="279"/>
        </pc:sldMkLst>
        <pc:spChg chg="del">
          <ac:chgData name="Peter Alexander" userId="6766396f-6837-4e3e-aa63-6649ea648b73" providerId="ADAL" clId="{B23E332B-9C9D-4BDB-AA2B-DEC72DABD394}" dt="2022-08-29T00:11:05.554" v="216" actId="478"/>
          <ac:spMkLst>
            <pc:docMk/>
            <pc:sldMk cId="10483774" sldId="279"/>
            <ac:spMk id="23" creationId="{0FDE3830-B993-4413-B7A4-F5C6D380CD0C}"/>
          </ac:spMkLst>
        </pc:spChg>
        <pc:spChg chg="del">
          <ac:chgData name="Peter Alexander" userId="6766396f-6837-4e3e-aa63-6649ea648b73" providerId="ADAL" clId="{B23E332B-9C9D-4BDB-AA2B-DEC72DABD394}" dt="2022-08-29T00:11:05.554" v="216" actId="478"/>
          <ac:spMkLst>
            <pc:docMk/>
            <pc:sldMk cId="10483774" sldId="279"/>
            <ac:spMk id="24" creationId="{B2AF52FD-582C-415F-829D-D85AD6B7AED5}"/>
          </ac:spMkLst>
        </pc:spChg>
        <pc:spChg chg="del">
          <ac:chgData name="Peter Alexander" userId="6766396f-6837-4e3e-aa63-6649ea648b73" providerId="ADAL" clId="{B23E332B-9C9D-4BDB-AA2B-DEC72DABD394}" dt="2022-08-29T00:11:05.554" v="216" actId="478"/>
          <ac:spMkLst>
            <pc:docMk/>
            <pc:sldMk cId="10483774" sldId="279"/>
            <ac:spMk id="40" creationId="{831774FF-EBF3-457B-8934-6CB632D1850F}"/>
          </ac:spMkLst>
        </pc:spChg>
        <pc:spChg chg="del">
          <ac:chgData name="Peter Alexander" userId="6766396f-6837-4e3e-aa63-6649ea648b73" providerId="ADAL" clId="{B23E332B-9C9D-4BDB-AA2B-DEC72DABD394}" dt="2022-08-29T00:11:05.554" v="216" actId="478"/>
          <ac:spMkLst>
            <pc:docMk/>
            <pc:sldMk cId="10483774" sldId="279"/>
            <ac:spMk id="44" creationId="{0BD72983-FAC6-4307-948D-EC8F0B1E9E8C}"/>
          </ac:spMkLst>
        </pc:spChg>
        <pc:spChg chg="mod">
          <ac:chgData name="Peter Alexander" userId="6766396f-6837-4e3e-aa63-6649ea648b73" providerId="ADAL" clId="{B23E332B-9C9D-4BDB-AA2B-DEC72DABD394}" dt="2022-08-29T00:11:13.028" v="217" actId="1076"/>
          <ac:spMkLst>
            <pc:docMk/>
            <pc:sldMk cId="10483774" sldId="279"/>
            <ac:spMk id="47" creationId="{9B346C6D-C47F-440D-BA63-297E8A2A06FA}"/>
          </ac:spMkLst>
        </pc:spChg>
        <pc:spChg chg="mod">
          <ac:chgData name="Peter Alexander" userId="6766396f-6837-4e3e-aa63-6649ea648b73" providerId="ADAL" clId="{B23E332B-9C9D-4BDB-AA2B-DEC72DABD394}" dt="2022-08-29T00:11:13.028" v="217" actId="1076"/>
          <ac:spMkLst>
            <pc:docMk/>
            <pc:sldMk cId="10483774" sldId="279"/>
            <ac:spMk id="48" creationId="{D72BD738-F85D-405B-8D2C-2C0053397235}"/>
          </ac:spMkLst>
        </pc:spChg>
        <pc:spChg chg="mod">
          <ac:chgData name="Peter Alexander" userId="6766396f-6837-4e3e-aa63-6649ea648b73" providerId="ADAL" clId="{B23E332B-9C9D-4BDB-AA2B-DEC72DABD394}" dt="2022-08-29T00:11:13.028" v="217" actId="1076"/>
          <ac:spMkLst>
            <pc:docMk/>
            <pc:sldMk cId="10483774" sldId="279"/>
            <ac:spMk id="49" creationId="{A5E15403-DA13-476F-A6CE-BFCF386CE587}"/>
          </ac:spMkLst>
        </pc:spChg>
        <pc:spChg chg="del">
          <ac:chgData name="Peter Alexander" userId="6766396f-6837-4e3e-aa63-6649ea648b73" providerId="ADAL" clId="{B23E332B-9C9D-4BDB-AA2B-DEC72DABD394}" dt="2022-08-29T00:11:05.554" v="216" actId="478"/>
          <ac:spMkLst>
            <pc:docMk/>
            <pc:sldMk cId="10483774" sldId="279"/>
            <ac:spMk id="56" creationId="{D82290E7-41EE-41FD-B9A8-36AEE9221A92}"/>
          </ac:spMkLst>
        </pc:spChg>
        <pc:spChg chg="del">
          <ac:chgData name="Peter Alexander" userId="6766396f-6837-4e3e-aa63-6649ea648b73" providerId="ADAL" clId="{B23E332B-9C9D-4BDB-AA2B-DEC72DABD394}" dt="2022-08-29T00:11:05.554" v="216" actId="478"/>
          <ac:spMkLst>
            <pc:docMk/>
            <pc:sldMk cId="10483774" sldId="279"/>
            <ac:spMk id="57" creationId="{B141667E-6D29-4903-993F-069798E39BD7}"/>
          </ac:spMkLst>
        </pc:spChg>
        <pc:spChg chg="mod">
          <ac:chgData name="Peter Alexander" userId="6766396f-6837-4e3e-aa63-6649ea648b73" providerId="ADAL" clId="{B23E332B-9C9D-4BDB-AA2B-DEC72DABD394}" dt="2022-08-29T00:12:40.955" v="253" actId="6549"/>
          <ac:spMkLst>
            <pc:docMk/>
            <pc:sldMk cId="10483774" sldId="279"/>
            <ac:spMk id="70" creationId="{32A4FA19-8136-4057-BAC8-B7325D0DBCB4}"/>
          </ac:spMkLst>
        </pc:spChg>
        <pc:spChg chg="mod">
          <ac:chgData name="Peter Alexander" userId="6766396f-6837-4e3e-aa63-6649ea648b73" providerId="ADAL" clId="{B23E332B-9C9D-4BDB-AA2B-DEC72DABD394}" dt="2022-08-29T00:12:48.701" v="254"/>
          <ac:spMkLst>
            <pc:docMk/>
            <pc:sldMk cId="10483774" sldId="279"/>
            <ac:spMk id="71" creationId="{95FF1D95-2200-4B25-B7B7-B6BA36D5C788}"/>
          </ac:spMkLst>
        </pc:spChg>
        <pc:spChg chg="mod">
          <ac:chgData name="Peter Alexander" userId="6766396f-6837-4e3e-aa63-6649ea648b73" providerId="ADAL" clId="{B23E332B-9C9D-4BDB-AA2B-DEC72DABD394}" dt="2022-08-29T00:13:05.496" v="255"/>
          <ac:spMkLst>
            <pc:docMk/>
            <pc:sldMk cId="10483774" sldId="279"/>
            <ac:spMk id="72" creationId="{8C3489FF-EB20-4E1F-B232-009F2B4754D3}"/>
          </ac:spMkLst>
        </pc:spChg>
        <pc:spChg chg="mod">
          <ac:chgData name="Peter Alexander" userId="6766396f-6837-4e3e-aa63-6649ea648b73" providerId="ADAL" clId="{B23E332B-9C9D-4BDB-AA2B-DEC72DABD394}" dt="2022-08-29T00:11:20.455" v="233" actId="20577"/>
          <ac:spMkLst>
            <pc:docMk/>
            <pc:sldMk cId="10483774" sldId="279"/>
            <ac:spMk id="85" creationId="{1F8E1AD1-DEBA-48A1-882D-07C2F5550448}"/>
          </ac:spMkLst>
        </pc:spChg>
        <pc:graphicFrameChg chg="del">
          <ac:chgData name="Peter Alexander" userId="6766396f-6837-4e3e-aa63-6649ea648b73" providerId="ADAL" clId="{B23E332B-9C9D-4BDB-AA2B-DEC72DABD394}" dt="2022-08-29T00:11:05.554" v="216" actId="478"/>
          <ac:graphicFrameMkLst>
            <pc:docMk/>
            <pc:sldMk cId="10483774" sldId="279"/>
            <ac:graphicFrameMk id="39" creationId="{066E2ED4-94EB-4998-B12A-317EE77AE801}"/>
          </ac:graphicFrameMkLst>
        </pc:graphicFrameChg>
        <pc:graphicFrameChg chg="del">
          <ac:chgData name="Peter Alexander" userId="6766396f-6837-4e3e-aa63-6649ea648b73" providerId="ADAL" clId="{B23E332B-9C9D-4BDB-AA2B-DEC72DABD394}" dt="2022-08-29T00:11:05.554" v="216" actId="478"/>
          <ac:graphicFrameMkLst>
            <pc:docMk/>
            <pc:sldMk cId="10483774" sldId="279"/>
            <ac:graphicFrameMk id="53" creationId="{89FA53AD-B480-4ABF-AD0A-9BF3140EC8F1}"/>
          </ac:graphicFrameMkLst>
        </pc:graphicFrameChg>
        <pc:graphicFrameChg chg="del">
          <ac:chgData name="Peter Alexander" userId="6766396f-6837-4e3e-aa63-6649ea648b73" providerId="ADAL" clId="{B23E332B-9C9D-4BDB-AA2B-DEC72DABD394}" dt="2022-08-29T00:11:05.554" v="216" actId="478"/>
          <ac:graphicFrameMkLst>
            <pc:docMk/>
            <pc:sldMk cId="10483774" sldId="279"/>
            <ac:graphicFrameMk id="54" creationId="{0CC63077-418A-47A0-BABC-44453C5195AF}"/>
          </ac:graphicFrameMkLst>
        </pc:graphicFrameChg>
        <pc:graphicFrameChg chg="mod">
          <ac:chgData name="Peter Alexander" userId="6766396f-6837-4e3e-aa63-6649ea648b73" providerId="ADAL" clId="{B23E332B-9C9D-4BDB-AA2B-DEC72DABD394}" dt="2022-08-29T00:11:13.028" v="217" actId="1076"/>
          <ac:graphicFrameMkLst>
            <pc:docMk/>
            <pc:sldMk cId="10483774" sldId="279"/>
            <ac:graphicFrameMk id="69" creationId="{4B34A4D1-EC68-4BC5-BD83-7CD0CAF1592A}"/>
          </ac:graphicFrameMkLst>
        </pc:graphicFrameChg>
        <pc:graphicFrameChg chg="mod">
          <ac:chgData name="Peter Alexander" userId="6766396f-6837-4e3e-aa63-6649ea648b73" providerId="ADAL" clId="{B23E332B-9C9D-4BDB-AA2B-DEC72DABD394}" dt="2022-08-29T00:11:13.028" v="217" actId="1076"/>
          <ac:graphicFrameMkLst>
            <pc:docMk/>
            <pc:sldMk cId="10483774" sldId="279"/>
            <ac:graphicFrameMk id="82" creationId="{7D00E389-806E-4836-A8A8-F5CCA96DFD99}"/>
          </ac:graphicFrameMkLst>
        </pc:graphicFrameChg>
        <pc:graphicFrameChg chg="mod">
          <ac:chgData name="Peter Alexander" userId="6766396f-6837-4e3e-aa63-6649ea648b73" providerId="ADAL" clId="{B23E332B-9C9D-4BDB-AA2B-DEC72DABD394}" dt="2022-08-29T00:11:13.028" v="217" actId="1076"/>
          <ac:graphicFrameMkLst>
            <pc:docMk/>
            <pc:sldMk cId="10483774" sldId="279"/>
            <ac:graphicFrameMk id="83" creationId="{275C919B-A170-4179-A241-68E4839E2460}"/>
          </ac:graphicFrameMkLst>
        </pc:graphicFrame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21" creationId="{A138FB3B-2DF6-404F-F815-4B91CDB32039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25" creationId="{9C9757C8-2F35-68B8-2406-C5CCE255F6EC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27" creationId="{847A01BB-994A-72F6-D7CD-0F1D2D8C9F5B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29" creationId="{161A5C68-B9AA-30B4-C437-6D4B5A886167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50" creationId="{5A51659B-E38B-E5BF-B6AD-6F7609EC88B4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51" creationId="{88C66601-4566-F7B9-B48E-D2196B6F33D4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52" creationId="{E770D41E-9DBA-D72D-D491-74DA230E4568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55" creationId="{6482E320-30B2-E179-6578-FF982D9C3843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58" creationId="{022E2897-5F0D-6C4C-8821-1F6425A34BC9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65" creationId="{FA7FFC34-1306-1EC8-C9D5-0B3B495B3AD5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66" creationId="{0D84A529-F5B4-1220-7423-D24D0D65A25E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67" creationId="{38E86CED-2E16-4DC5-7A99-7573D1B0031E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68" creationId="{DED9D9AE-CFE8-0D75-FBEB-C79BE96D839A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84" creationId="{1116C722-5A97-B83A-DD13-D479DBBFB9CE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86" creationId="{589FF55F-BD30-F646-C513-9F647ADF8A53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87" creationId="{8C86A96E-C20A-7E57-0B26-1200121A2375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88" creationId="{C58E2A94-B4FD-4175-B9B5-C60B8441D2E7}"/>
          </ac:picMkLst>
        </pc:picChg>
        <pc:picChg chg="mod">
          <ac:chgData name="Peter Alexander" userId="6766396f-6837-4e3e-aa63-6649ea648b73" providerId="ADAL" clId="{B23E332B-9C9D-4BDB-AA2B-DEC72DABD394}" dt="2022-08-29T00:11:13.028" v="217" actId="1076"/>
          <ac:picMkLst>
            <pc:docMk/>
            <pc:sldMk cId="10483774" sldId="279"/>
            <ac:picMk id="89" creationId="{A23C1423-5A33-EBC6-0017-8B77802A71C3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90" creationId="{D8FE9459-B904-8035-15A9-7FDE2B73DA6A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91" creationId="{7D28010C-6EE9-F851-E0F8-849F3F34E6BB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92" creationId="{9311FFCE-C36A-3159-2C66-83AF16F9BBA6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93" creationId="{04CD25F2-B592-2C58-7932-699E0BFCAD42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94" creationId="{292A38BF-CA37-1F36-B970-0472B74B19F4}"/>
          </ac:picMkLst>
        </pc:picChg>
        <pc:picChg chg="del">
          <ac:chgData name="Peter Alexander" userId="6766396f-6837-4e3e-aa63-6649ea648b73" providerId="ADAL" clId="{B23E332B-9C9D-4BDB-AA2B-DEC72DABD394}" dt="2022-08-29T00:11:05.554" v="216" actId="478"/>
          <ac:picMkLst>
            <pc:docMk/>
            <pc:sldMk cId="10483774" sldId="279"/>
            <ac:picMk id="95" creationId="{199F5CD6-FAD5-4A36-FA64-E4BCF32280D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0"/>
            <a:ext cx="10363200" cy="1470025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365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8293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3"/>
            <a:ext cx="2743200" cy="5851525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3"/>
            <a:ext cx="8026400" cy="585152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687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36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4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6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5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8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1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9735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7722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3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6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9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3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8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3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3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6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9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3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8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3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1828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966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251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6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5" y="273055"/>
            <a:ext cx="681566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6" y="1435104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78" indent="0">
              <a:buNone/>
              <a:defRPr sz="1200"/>
            </a:lvl2pPr>
            <a:lvl3pPr marL="914356" indent="0">
              <a:buNone/>
              <a:defRPr sz="1000"/>
            </a:lvl3pPr>
            <a:lvl4pPr marL="1371532" indent="0">
              <a:buNone/>
              <a:defRPr sz="900"/>
            </a:lvl4pPr>
            <a:lvl5pPr marL="1828709" indent="0">
              <a:buNone/>
              <a:defRPr sz="900"/>
            </a:lvl5pPr>
            <a:lvl6pPr marL="2285886" indent="0">
              <a:buNone/>
              <a:defRPr sz="900"/>
            </a:lvl6pPr>
            <a:lvl7pPr marL="2743063" indent="0">
              <a:buNone/>
              <a:defRPr sz="900"/>
            </a:lvl7pPr>
            <a:lvl8pPr marL="3200240" indent="0">
              <a:buNone/>
              <a:defRPr sz="900"/>
            </a:lvl8pPr>
            <a:lvl9pPr marL="3657418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9703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1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78" indent="0">
              <a:buNone/>
              <a:defRPr sz="2800"/>
            </a:lvl2pPr>
            <a:lvl3pPr marL="914356" indent="0">
              <a:buNone/>
              <a:defRPr sz="2400"/>
            </a:lvl3pPr>
            <a:lvl4pPr marL="1371532" indent="0">
              <a:buNone/>
              <a:defRPr sz="2000"/>
            </a:lvl4pPr>
            <a:lvl5pPr marL="1828709" indent="0">
              <a:buNone/>
              <a:defRPr sz="2000"/>
            </a:lvl5pPr>
            <a:lvl6pPr marL="2285886" indent="0">
              <a:buNone/>
              <a:defRPr sz="2000"/>
            </a:lvl6pPr>
            <a:lvl7pPr marL="2743063" indent="0">
              <a:buNone/>
              <a:defRPr sz="2000"/>
            </a:lvl7pPr>
            <a:lvl8pPr marL="3200240" indent="0">
              <a:buNone/>
              <a:defRPr sz="2000"/>
            </a:lvl8pPr>
            <a:lvl9pPr marL="3657418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9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78" indent="0">
              <a:buNone/>
              <a:defRPr sz="1200"/>
            </a:lvl2pPr>
            <a:lvl3pPr marL="914356" indent="0">
              <a:buNone/>
              <a:defRPr sz="1000"/>
            </a:lvl3pPr>
            <a:lvl4pPr marL="1371532" indent="0">
              <a:buNone/>
              <a:defRPr sz="900"/>
            </a:lvl4pPr>
            <a:lvl5pPr marL="1828709" indent="0">
              <a:buNone/>
              <a:defRPr sz="900"/>
            </a:lvl5pPr>
            <a:lvl6pPr marL="2285886" indent="0">
              <a:buNone/>
              <a:defRPr sz="900"/>
            </a:lvl6pPr>
            <a:lvl7pPr marL="2743063" indent="0">
              <a:buNone/>
              <a:defRPr sz="900"/>
            </a:lvl7pPr>
            <a:lvl8pPr marL="3200240" indent="0">
              <a:buNone/>
              <a:defRPr sz="900"/>
            </a:lvl8pPr>
            <a:lvl9pPr marL="3657418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0899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5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5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465EE-A4D9-134A-8D6E-3B64169AE104}" type="datetimeFigureOut">
              <a:rPr lang="en-US" smtClean="0"/>
              <a:t>8/2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5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5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82705-4B44-6541-AF71-439368B042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948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3" indent="-342883" algn="l" defTabSz="457178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12" indent="-285736" algn="l" defTabSz="457178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43" indent="-228589" algn="l" defTabSz="457178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20" indent="-228589" algn="l" defTabSz="457178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97" indent="-228589" algn="l" defTabSz="457178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74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52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29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06" indent="-228589" algn="l" defTabSz="457178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8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56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32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09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86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63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40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18" algn="l" defTabSz="4571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>
            <a:extLst>
              <a:ext uri="{FF2B5EF4-FFF2-40B4-BE49-F238E27FC236}">
                <a16:creationId xmlns:a16="http://schemas.microsoft.com/office/drawing/2014/main" id="{9C9757C8-2F35-68B8-2406-C5CCE255F6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1866" y="2126301"/>
            <a:ext cx="3144719" cy="204091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A138FB3B-2DF6-404F-F815-4B91CDB320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24246" y="2155148"/>
            <a:ext cx="3144719" cy="2040919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5A51659B-E38B-E5BF-B6AD-6F7609EC88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4951" y="2129109"/>
            <a:ext cx="3146407" cy="1945659"/>
          </a:xfrm>
          <a:prstGeom prst="rect">
            <a:avLst/>
          </a:prstGeom>
        </p:spPr>
      </p:pic>
      <p:graphicFrame>
        <p:nvGraphicFramePr>
          <p:cNvPr id="69" name="Table 68">
            <a:extLst>
              <a:ext uri="{FF2B5EF4-FFF2-40B4-BE49-F238E27FC236}">
                <a16:creationId xmlns:a16="http://schemas.microsoft.com/office/drawing/2014/main" id="{4B34A4D1-EC68-4BC5-BD83-7CD0CAF159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3650684"/>
              </p:ext>
            </p:extLst>
          </p:nvPr>
        </p:nvGraphicFramePr>
        <p:xfrm>
          <a:off x="7862251" y="3713611"/>
          <a:ext cx="3648927" cy="96815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08573">
                  <a:extLst>
                    <a:ext uri="{9D8B030D-6E8A-4147-A177-3AD203B41FA5}">
                      <a16:colId xmlns:a16="http://schemas.microsoft.com/office/drawing/2014/main" val="2062936192"/>
                    </a:ext>
                  </a:extLst>
                </a:gridCol>
                <a:gridCol w="490059">
                  <a:extLst>
                    <a:ext uri="{9D8B030D-6E8A-4147-A177-3AD203B41FA5}">
                      <a16:colId xmlns:a16="http://schemas.microsoft.com/office/drawing/2014/main" val="1854329231"/>
                    </a:ext>
                  </a:extLst>
                </a:gridCol>
                <a:gridCol w="490059">
                  <a:extLst>
                    <a:ext uri="{9D8B030D-6E8A-4147-A177-3AD203B41FA5}">
                      <a16:colId xmlns:a16="http://schemas.microsoft.com/office/drawing/2014/main" val="3702083025"/>
                    </a:ext>
                  </a:extLst>
                </a:gridCol>
                <a:gridCol w="490059">
                  <a:extLst>
                    <a:ext uri="{9D8B030D-6E8A-4147-A177-3AD203B41FA5}">
                      <a16:colId xmlns:a16="http://schemas.microsoft.com/office/drawing/2014/main" val="2429787282"/>
                    </a:ext>
                  </a:extLst>
                </a:gridCol>
                <a:gridCol w="490059">
                  <a:extLst>
                    <a:ext uri="{9D8B030D-6E8A-4147-A177-3AD203B41FA5}">
                      <a16:colId xmlns:a16="http://schemas.microsoft.com/office/drawing/2014/main" val="977282547"/>
                    </a:ext>
                  </a:extLst>
                </a:gridCol>
                <a:gridCol w="490059">
                  <a:extLst>
                    <a:ext uri="{9D8B030D-6E8A-4147-A177-3AD203B41FA5}">
                      <a16:colId xmlns:a16="http://schemas.microsoft.com/office/drawing/2014/main" val="2696187140"/>
                    </a:ext>
                  </a:extLst>
                </a:gridCol>
                <a:gridCol w="490059">
                  <a:extLst>
                    <a:ext uri="{9D8B030D-6E8A-4147-A177-3AD203B41FA5}">
                      <a16:colId xmlns:a16="http://schemas.microsoft.com/office/drawing/2014/main" val="2028114309"/>
                    </a:ext>
                  </a:extLst>
                </a:gridCol>
              </a:tblGrid>
              <a:tr h="344498">
                <a:tc>
                  <a:txBody>
                    <a:bodyPr/>
                    <a:lstStyle/>
                    <a:p>
                      <a:pPr marL="0" marR="0" lvl="0" indent="0" algn="r" defTabSz="4571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 at risk</a:t>
                      </a:r>
                    </a:p>
                  </a:txBody>
                  <a:tcPr anchor="ctr">
                    <a:noFill/>
                  </a:tcPr>
                </a:tc>
                <a:tc gridSpan="6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3553501"/>
                  </a:ext>
                </a:extLst>
              </a:tr>
              <a:tr h="207887">
                <a:tc>
                  <a:txBody>
                    <a:bodyPr/>
                    <a:lstStyle/>
                    <a:p>
                      <a:pPr algn="r"/>
                      <a:r>
                        <a:rPr lang="en-GB" sz="7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5   (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0   (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9  (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5  (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4  (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6  (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2120049"/>
                  </a:ext>
                </a:extLst>
              </a:tr>
              <a:tr h="207887">
                <a:tc>
                  <a:txBody>
                    <a:bodyPr/>
                    <a:lstStyle/>
                    <a:p>
                      <a:pPr algn="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35 (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14 (3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89  (9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78  (1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66  (1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1  (1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5954205"/>
                  </a:ext>
                </a:extLst>
              </a:tr>
              <a:tr h="207887">
                <a:tc>
                  <a:txBody>
                    <a:bodyPr/>
                    <a:lstStyle/>
                    <a:p>
                      <a:pPr algn="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2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2   (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7   (4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1  (6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9  (6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5  (6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8    (6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0383864"/>
                  </a:ext>
                </a:extLst>
              </a:tr>
            </a:tbl>
          </a:graphicData>
        </a:graphic>
      </p:graphicFrame>
      <p:sp>
        <p:nvSpPr>
          <p:cNvPr id="70" name="Text Box 2">
            <a:extLst>
              <a:ext uri="{FF2B5EF4-FFF2-40B4-BE49-F238E27FC236}">
                <a16:creationId xmlns:a16="http://schemas.microsoft.com/office/drawing/2014/main" id="{32A4FA19-8136-4057-BAC8-B7325D0DBC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8406" y="2935911"/>
            <a:ext cx="2657007" cy="780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</a:pPr>
            <a:r>
              <a:rPr lang="en-GB" sz="800" b="1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Local+-systemic recurrence in full cohort</a:t>
            </a: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0		</a:t>
            </a:r>
            <a:endParaRPr lang="en-GB" sz="800" i="1" dirty="0">
              <a:latin typeface="Times New Roman" panose="0202060305040502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1	 </a:t>
            </a: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2		 HR 3.95 95% CI 1.56-9.99, </a:t>
            </a:r>
            <a:r>
              <a:rPr lang="en-GB" sz="800" i="1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=0.009</a:t>
            </a:r>
          </a:p>
          <a:p>
            <a:pPr>
              <a:lnSpc>
                <a:spcPct val="107000"/>
              </a:lnSpc>
            </a:pPr>
            <a:endParaRPr lang="en-GB" sz="800" dirty="0">
              <a:latin typeface="Times New Roman" panose="0202060305040502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</a:pPr>
            <a:endParaRPr lang="en-GB" sz="800" dirty="0">
              <a:latin typeface="Times New Roman" panose="0202060305040502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1" name="Text Box 2">
            <a:extLst>
              <a:ext uri="{FF2B5EF4-FFF2-40B4-BE49-F238E27FC236}">
                <a16:creationId xmlns:a16="http://schemas.microsoft.com/office/drawing/2014/main" id="{95FF1D95-2200-4B25-B7B7-B6BA36D5C7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5822" y="2939520"/>
            <a:ext cx="2649544" cy="780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</a:pPr>
            <a:r>
              <a:rPr lang="en-GB" sz="800" b="1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Local+-systemic recurrence in colon cancers</a:t>
            </a: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0		</a:t>
            </a:r>
            <a:endParaRPr lang="en-GB" sz="800" i="1" dirty="0">
              <a:latin typeface="Times New Roman" panose="0202060305040502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1	 </a:t>
            </a: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2		 HR 3.66 95% CI 1.18-11.36, </a:t>
            </a:r>
            <a:r>
              <a:rPr lang="en-GB" sz="800" i="1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=0.07</a:t>
            </a:r>
          </a:p>
          <a:p>
            <a:pPr>
              <a:lnSpc>
                <a:spcPct val="107000"/>
              </a:lnSpc>
            </a:pPr>
            <a:endParaRPr lang="en-GB" sz="800" dirty="0">
              <a:latin typeface="Times New Roman" panose="0202060305040502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2" name="Text Box 2">
            <a:extLst>
              <a:ext uri="{FF2B5EF4-FFF2-40B4-BE49-F238E27FC236}">
                <a16:creationId xmlns:a16="http://schemas.microsoft.com/office/drawing/2014/main" id="{8C3489FF-EB20-4E1F-B232-009F2B4754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55569" y="2933382"/>
            <a:ext cx="2626287" cy="780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</a:pPr>
            <a:r>
              <a:rPr lang="en-GB" sz="800" b="1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Local+-systemic recurrence in rectal cancers</a:t>
            </a: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0		</a:t>
            </a:r>
            <a:endParaRPr lang="en-GB" sz="800" i="1" dirty="0">
              <a:latin typeface="Times New Roman" panose="0202060305040502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1	 </a:t>
            </a:r>
          </a:p>
          <a:p>
            <a:pPr>
              <a:lnSpc>
                <a:spcPct val="107000"/>
              </a:lnSpc>
            </a:pP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GMS 2		 HR 3.92 95% CI 0.78-19.77, </a:t>
            </a:r>
            <a:r>
              <a:rPr lang="en-GB" sz="800" i="1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=0.10</a:t>
            </a:r>
          </a:p>
          <a:p>
            <a:pPr>
              <a:lnSpc>
                <a:spcPct val="107000"/>
              </a:lnSpc>
            </a:pPr>
            <a:endParaRPr lang="en-GB" sz="800" dirty="0">
              <a:latin typeface="Times New Roman" panose="0202060305040502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82" name="Table 81">
            <a:extLst>
              <a:ext uri="{FF2B5EF4-FFF2-40B4-BE49-F238E27FC236}">
                <a16:creationId xmlns:a16="http://schemas.microsoft.com/office/drawing/2014/main" id="{7D00E389-806E-4836-A8A8-F5CCA96DFD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6709558"/>
              </p:ext>
            </p:extLst>
          </p:nvPr>
        </p:nvGraphicFramePr>
        <p:xfrm>
          <a:off x="4207188" y="3721497"/>
          <a:ext cx="3666780" cy="9555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22820">
                  <a:extLst>
                    <a:ext uri="{9D8B030D-6E8A-4147-A177-3AD203B41FA5}">
                      <a16:colId xmlns:a16="http://schemas.microsoft.com/office/drawing/2014/main" val="2062936192"/>
                    </a:ext>
                  </a:extLst>
                </a:gridCol>
                <a:gridCol w="413329">
                  <a:extLst>
                    <a:ext uri="{9D8B030D-6E8A-4147-A177-3AD203B41FA5}">
                      <a16:colId xmlns:a16="http://schemas.microsoft.com/office/drawing/2014/main" val="1854329231"/>
                    </a:ext>
                  </a:extLst>
                </a:gridCol>
                <a:gridCol w="495998">
                  <a:extLst>
                    <a:ext uri="{9D8B030D-6E8A-4147-A177-3AD203B41FA5}">
                      <a16:colId xmlns:a16="http://schemas.microsoft.com/office/drawing/2014/main" val="3702083025"/>
                    </a:ext>
                  </a:extLst>
                </a:gridCol>
                <a:gridCol w="504263">
                  <a:extLst>
                    <a:ext uri="{9D8B030D-6E8A-4147-A177-3AD203B41FA5}">
                      <a16:colId xmlns:a16="http://schemas.microsoft.com/office/drawing/2014/main" val="2429787282"/>
                    </a:ext>
                  </a:extLst>
                </a:gridCol>
                <a:gridCol w="469827">
                  <a:extLst>
                    <a:ext uri="{9D8B030D-6E8A-4147-A177-3AD203B41FA5}">
                      <a16:colId xmlns:a16="http://schemas.microsoft.com/office/drawing/2014/main" val="977282547"/>
                    </a:ext>
                  </a:extLst>
                </a:gridCol>
                <a:gridCol w="547905">
                  <a:extLst>
                    <a:ext uri="{9D8B030D-6E8A-4147-A177-3AD203B41FA5}">
                      <a16:colId xmlns:a16="http://schemas.microsoft.com/office/drawing/2014/main" val="2696187140"/>
                    </a:ext>
                  </a:extLst>
                </a:gridCol>
                <a:gridCol w="512638">
                  <a:extLst>
                    <a:ext uri="{9D8B030D-6E8A-4147-A177-3AD203B41FA5}">
                      <a16:colId xmlns:a16="http://schemas.microsoft.com/office/drawing/2014/main" val="2028114309"/>
                    </a:ext>
                  </a:extLst>
                </a:gridCol>
              </a:tblGrid>
              <a:tr h="347707">
                <a:tc>
                  <a:txBody>
                    <a:bodyPr/>
                    <a:lstStyle/>
                    <a:p>
                      <a:pPr marL="0" marR="0" lvl="0" indent="0" algn="r" defTabSz="4571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 at risk</a:t>
                      </a:r>
                    </a:p>
                  </a:txBody>
                  <a:tcPr anchor="ctr">
                    <a:noFill/>
                  </a:tcPr>
                </a:tc>
                <a:tc gridSpan="6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3553501"/>
                  </a:ext>
                </a:extLst>
              </a:tr>
              <a:tr h="200856">
                <a:tc>
                  <a:txBody>
                    <a:bodyPr/>
                    <a:lstStyle/>
                    <a:p>
                      <a:pPr algn="r"/>
                      <a:r>
                        <a:rPr lang="en-GB" sz="7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89   (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81   (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71   (3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65   (4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55   (4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7     (4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2120049"/>
                  </a:ext>
                </a:extLst>
              </a:tr>
              <a:tr h="200856">
                <a:tc>
                  <a:txBody>
                    <a:bodyPr/>
                    <a:lstStyle/>
                    <a:p>
                      <a:pPr algn="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38 (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78 (13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34 (2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08 (26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60 (31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04   (31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5954205"/>
                  </a:ext>
                </a:extLst>
              </a:tr>
              <a:tr h="206104">
                <a:tc>
                  <a:txBody>
                    <a:bodyPr/>
                    <a:lstStyle/>
                    <a:p>
                      <a:pPr algn="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2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95   (0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65   (8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54   (9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4   (1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5   (1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8     (12)</a:t>
                      </a: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0383864"/>
                  </a:ext>
                </a:extLst>
              </a:tr>
            </a:tbl>
          </a:graphicData>
        </a:graphic>
      </p:graphicFrame>
      <p:sp>
        <p:nvSpPr>
          <p:cNvPr id="47" name="Text Box 2">
            <a:extLst>
              <a:ext uri="{FF2B5EF4-FFF2-40B4-BE49-F238E27FC236}">
                <a16:creationId xmlns:a16="http://schemas.microsoft.com/office/drawing/2014/main" id="{9B346C6D-C47F-440D-BA63-297E8A2A06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1703" y="1700061"/>
            <a:ext cx="214693" cy="27973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</a:pPr>
            <a:r>
              <a:rPr lang="en-GB" sz="1400" b="1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A</a:t>
            </a:r>
            <a:endParaRPr lang="en-GB" sz="1400" dirty="0">
              <a:latin typeface="Calibri" panose="020F0502020204030204" pitchFamily="34" charset="0"/>
              <a:ea typeface="DengXian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48" name="Text Box 2">
            <a:extLst>
              <a:ext uri="{FF2B5EF4-FFF2-40B4-BE49-F238E27FC236}">
                <a16:creationId xmlns:a16="http://schemas.microsoft.com/office/drawing/2014/main" id="{D72BD738-F85D-405B-8D2C-2C00533972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6837" y="1700061"/>
            <a:ext cx="214693" cy="27973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</a:pPr>
            <a:r>
              <a:rPr lang="en-GB" sz="1400" b="1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B</a:t>
            </a:r>
            <a:endParaRPr lang="en-GB" sz="1400" dirty="0">
              <a:latin typeface="Calibri" panose="020F0502020204030204" pitchFamily="34" charset="0"/>
              <a:ea typeface="DengXian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49" name="Text Box 2">
            <a:extLst>
              <a:ext uri="{FF2B5EF4-FFF2-40B4-BE49-F238E27FC236}">
                <a16:creationId xmlns:a16="http://schemas.microsoft.com/office/drawing/2014/main" id="{A5E15403-DA13-476F-A6CE-BFCF386CE5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33984" y="1700061"/>
            <a:ext cx="214693" cy="27973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</a:pPr>
            <a:r>
              <a:rPr lang="en-GB" sz="1400" b="1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C</a:t>
            </a:r>
            <a:endParaRPr lang="en-GB" sz="1400" dirty="0">
              <a:latin typeface="Calibri" panose="020F0502020204030204" pitchFamily="34" charset="0"/>
              <a:ea typeface="DengXian" panose="02010600030101010101" pitchFamily="2" charset="-122"/>
              <a:cs typeface="Calibri" panose="020F0502020204030204" pitchFamily="34" charset="0"/>
            </a:endParaRPr>
          </a:p>
        </p:txBody>
      </p:sp>
      <p:graphicFrame>
        <p:nvGraphicFramePr>
          <p:cNvPr id="83" name="Table 82">
            <a:extLst>
              <a:ext uri="{FF2B5EF4-FFF2-40B4-BE49-F238E27FC236}">
                <a16:creationId xmlns:a16="http://schemas.microsoft.com/office/drawing/2014/main" id="{275C919B-A170-4179-A241-68E4839E24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8275372"/>
              </p:ext>
            </p:extLst>
          </p:nvPr>
        </p:nvGraphicFramePr>
        <p:xfrm>
          <a:off x="614721" y="3708075"/>
          <a:ext cx="3700693" cy="9555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30897">
                  <a:extLst>
                    <a:ext uri="{9D8B030D-6E8A-4147-A177-3AD203B41FA5}">
                      <a16:colId xmlns:a16="http://schemas.microsoft.com/office/drawing/2014/main" val="2062936192"/>
                    </a:ext>
                  </a:extLst>
                </a:gridCol>
                <a:gridCol w="494966">
                  <a:extLst>
                    <a:ext uri="{9D8B030D-6E8A-4147-A177-3AD203B41FA5}">
                      <a16:colId xmlns:a16="http://schemas.microsoft.com/office/drawing/2014/main" val="1854329231"/>
                    </a:ext>
                  </a:extLst>
                </a:gridCol>
                <a:gridCol w="494966">
                  <a:extLst>
                    <a:ext uri="{9D8B030D-6E8A-4147-A177-3AD203B41FA5}">
                      <a16:colId xmlns:a16="http://schemas.microsoft.com/office/drawing/2014/main" val="3702083025"/>
                    </a:ext>
                  </a:extLst>
                </a:gridCol>
                <a:gridCol w="494966">
                  <a:extLst>
                    <a:ext uri="{9D8B030D-6E8A-4147-A177-3AD203B41FA5}">
                      <a16:colId xmlns:a16="http://schemas.microsoft.com/office/drawing/2014/main" val="2429787282"/>
                    </a:ext>
                  </a:extLst>
                </a:gridCol>
                <a:gridCol w="494966">
                  <a:extLst>
                    <a:ext uri="{9D8B030D-6E8A-4147-A177-3AD203B41FA5}">
                      <a16:colId xmlns:a16="http://schemas.microsoft.com/office/drawing/2014/main" val="977282547"/>
                    </a:ext>
                  </a:extLst>
                </a:gridCol>
                <a:gridCol w="494966">
                  <a:extLst>
                    <a:ext uri="{9D8B030D-6E8A-4147-A177-3AD203B41FA5}">
                      <a16:colId xmlns:a16="http://schemas.microsoft.com/office/drawing/2014/main" val="2696187140"/>
                    </a:ext>
                  </a:extLst>
                </a:gridCol>
                <a:gridCol w="494966">
                  <a:extLst>
                    <a:ext uri="{9D8B030D-6E8A-4147-A177-3AD203B41FA5}">
                      <a16:colId xmlns:a16="http://schemas.microsoft.com/office/drawing/2014/main" val="2028114309"/>
                    </a:ext>
                  </a:extLst>
                </a:gridCol>
              </a:tblGrid>
              <a:tr h="361164">
                <a:tc>
                  <a:txBody>
                    <a:bodyPr/>
                    <a:lstStyle/>
                    <a:p>
                      <a:pPr marL="0" marR="0" lvl="0" indent="0" algn="r" defTabSz="45717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 at risk</a:t>
                      </a:r>
                    </a:p>
                  </a:txBody>
                  <a:tcPr anchor="ctr">
                    <a:noFill/>
                  </a:tcPr>
                </a:tc>
                <a:tc gridSpan="6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7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3553501"/>
                  </a:ext>
                </a:extLst>
              </a:tr>
              <a:tr h="177303">
                <a:tc>
                  <a:txBody>
                    <a:bodyPr/>
                    <a:lstStyle/>
                    <a:p>
                      <a:pPr algn="r"/>
                      <a:r>
                        <a:rPr lang="en-GB" sz="7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24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0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11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4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00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5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90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6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79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6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53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6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2120049"/>
                  </a:ext>
                </a:extLst>
              </a:tr>
              <a:tr h="177303">
                <a:tc>
                  <a:txBody>
                    <a:bodyPr/>
                    <a:lstStyle/>
                    <a:p>
                      <a:pPr algn="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73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0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92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16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23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29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86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36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26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41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45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41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5954205"/>
                  </a:ext>
                </a:extLst>
              </a:tr>
              <a:tr h="177303">
                <a:tc>
                  <a:txBody>
                    <a:bodyPr/>
                    <a:lstStyle/>
                    <a:p>
                      <a:pPr algn="r"/>
                      <a:r>
                        <a:rPr lang="en-GB" sz="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S 2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37 (0)</a:t>
                      </a: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92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12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75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15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63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18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(18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6 </a:t>
                      </a:r>
                      <a:r>
                        <a:rPr lang="en-GB" sz="7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(18)</a:t>
                      </a:r>
                      <a:endParaRPr lang="en-GB" sz="7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0383864"/>
                  </a:ext>
                </a:extLst>
              </a:tr>
            </a:tbl>
          </a:graphicData>
        </a:graphic>
      </p:graphicFrame>
      <p:sp>
        <p:nvSpPr>
          <p:cNvPr id="85" name="TextBox 84">
            <a:extLst>
              <a:ext uri="{FF2B5EF4-FFF2-40B4-BE49-F238E27FC236}">
                <a16:creationId xmlns:a16="http://schemas.microsoft.com/office/drawing/2014/main" id="{1F8E1AD1-DEBA-48A1-882D-07C2F5550448}"/>
              </a:ext>
            </a:extLst>
          </p:cNvPr>
          <p:cNvSpPr txBox="1"/>
          <p:nvPr/>
        </p:nvSpPr>
        <p:spPr>
          <a:xfrm>
            <a:off x="299837" y="1132734"/>
            <a:ext cx="11959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Supplementary Figure 1. Local recurrence (+- systemic involvement), (A-C) stratified by GMS in: </a:t>
            </a:r>
            <a:r>
              <a:rPr lang="en-GB" sz="1400" dirty="0"/>
              <a:t>(A) full cohort; (B) colon cancers; (C) in rectal cancers</a:t>
            </a:r>
            <a:endParaRPr lang="en-US" sz="1400" dirty="0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88C66601-4566-F7B9-B48E-D2196B6F33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95933" y="3141349"/>
            <a:ext cx="205736" cy="45719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E770D41E-9DBA-D72D-D491-74DA230E456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01616" y="3268613"/>
            <a:ext cx="200053" cy="47632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6482E320-30B2-E179-6578-FF982D9C38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11142" y="3412778"/>
            <a:ext cx="190527" cy="47632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DED9D9AE-CFE8-0D75-FBEB-C79BE96D83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26858" y="3135685"/>
            <a:ext cx="205736" cy="45719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1116C722-5A97-B83A-DD13-D479DBBFB9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32541" y="3262949"/>
            <a:ext cx="200053" cy="47632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589FF55F-BD30-F646-C513-9F647ADF8A5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42067" y="3407114"/>
            <a:ext cx="190527" cy="47632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8C86A96E-C20A-7E57-0B26-1200121A23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02132" y="3141349"/>
            <a:ext cx="205736" cy="45719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C58E2A94-B4FD-4175-B9B5-C60B8441D2E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07815" y="3268613"/>
            <a:ext cx="200053" cy="47632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A23C1423-5A33-EBC6-0017-8B77802A71C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17341" y="3412778"/>
            <a:ext cx="190527" cy="47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83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E4D50F6C5BD7347983E6E4FAE417112" ma:contentTypeVersion="12" ma:contentTypeDescription="Create a new document." ma:contentTypeScope="" ma:versionID="4f120353f803db966eddd3a8714ab5d9">
  <xsd:schema xmlns:xsd="http://www.w3.org/2001/XMLSchema" xmlns:xs="http://www.w3.org/2001/XMLSchema" xmlns:p="http://schemas.microsoft.com/office/2006/metadata/properties" xmlns:ns3="a15f8803-e726-413b-acdf-f1a868591d0a" xmlns:ns4="63f1e6be-b7f2-4620-bd9a-7627e231fe56" targetNamespace="http://schemas.microsoft.com/office/2006/metadata/properties" ma:root="true" ma:fieldsID="a7bba3542aea7882a3968697db87ee08" ns3:_="" ns4:_="">
    <xsd:import namespace="a15f8803-e726-413b-acdf-f1a868591d0a"/>
    <xsd:import namespace="63f1e6be-b7f2-4620-bd9a-7627e231fe5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15f8803-e726-413b-acdf-f1a868591d0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3f1e6be-b7f2-4620-bd9a-7627e231fe56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05ABA3C-5D1A-475F-B1DD-7636E5FC0AC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15f8803-e726-413b-acdf-f1a868591d0a"/>
    <ds:schemaRef ds:uri="63f1e6be-b7f2-4620-bd9a-7627e231fe5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FDA1EBE-D282-4D21-93DA-2BC2A32FB6D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EC01AAD-05B1-44FD-A91D-7D0355754CD9}">
  <ds:schemaRefs>
    <ds:schemaRef ds:uri="http://schemas.microsoft.com/office/2006/metadata/properties"/>
    <ds:schemaRef ds:uri="a15f8803-e726-413b-acdf-f1a868591d0a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63f1e6be-b7f2-4620-bd9a-7627e231fe56"/>
    <ds:schemaRef ds:uri="http://purl.org/dc/dcmitype/"/>
    <ds:schemaRef ds:uri="http://schemas.microsoft.com/office/infopath/2007/PartnerControls"/>
    <ds:schemaRef ds:uri="http://purl.org/dc/elements/1.1/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71</TotalTime>
  <Words>378</Words>
  <Application>Microsoft Office PowerPoint</Application>
  <PresentationFormat>Widescreen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a Roseweir</dc:creator>
  <cp:lastModifiedBy>Pete n' Ruthie Alexander</cp:lastModifiedBy>
  <cp:revision>93</cp:revision>
  <dcterms:created xsi:type="dcterms:W3CDTF">2019-11-29T14:24:20Z</dcterms:created>
  <dcterms:modified xsi:type="dcterms:W3CDTF">2022-08-29T00:13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E4D50F6C5BD7347983E6E4FAE417112</vt:lpwstr>
  </property>
</Properties>
</file>